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5" r:id="rId2"/>
    <p:sldId id="290" r:id="rId3"/>
    <p:sldId id="286" r:id="rId4"/>
    <p:sldId id="287" r:id="rId5"/>
    <p:sldId id="278" r:id="rId6"/>
    <p:sldId id="270" r:id="rId7"/>
    <p:sldId id="281" r:id="rId8"/>
    <p:sldId id="288" r:id="rId9"/>
    <p:sldId id="275" r:id="rId10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14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7981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1137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8478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9731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9264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6965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9620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4560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9144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8692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2913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B000C-A9F9-40B8-927D-1B5BCB61E587}" type="datetimeFigureOut">
              <a:rPr lang="ko-KR" altLang="en-US" smtClean="0"/>
              <a:t>2020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1FFDB-D145-43EF-BA4E-37DC3CBA4E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9035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0A6C8E33-27EA-4864-B98F-8EA6CE8BD5EB}"/>
              </a:ext>
            </a:extLst>
          </p:cNvPr>
          <p:cNvSpPr txBox="1"/>
          <p:nvPr/>
        </p:nvSpPr>
        <p:spPr>
          <a:xfrm>
            <a:off x="205042" y="139328"/>
            <a:ext cx="2698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ko-K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xmlns="" id="{8ECA7D5C-B203-41E7-90E5-07375005E6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349" y="623722"/>
            <a:ext cx="3010652" cy="2650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89075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2C39908C-3F31-4272-8306-4C149520EC49}"/>
              </a:ext>
            </a:extLst>
          </p:cNvPr>
          <p:cNvSpPr txBox="1"/>
          <p:nvPr/>
        </p:nvSpPr>
        <p:spPr>
          <a:xfrm>
            <a:off x="263750" y="98580"/>
            <a:ext cx="25122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table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xmlns="" id="{5DB02100-B024-47FF-A484-DEDD35C5C4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750" y="467912"/>
            <a:ext cx="6337079" cy="9366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29428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17880" y="692475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4129" y="27061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1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521" y="1061807"/>
            <a:ext cx="5605041" cy="451264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114E1D5-1B35-4D17-BC5C-A1FB0437E660}"/>
              </a:ext>
            </a:extLst>
          </p:cNvPr>
          <p:cNvSpPr txBox="1"/>
          <p:nvPr/>
        </p:nvSpPr>
        <p:spPr>
          <a:xfrm>
            <a:off x="333922" y="5814526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xmlns="" id="{8A03BF03-38F1-4850-99A1-2D71A153CD1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243" r="4154"/>
          <a:stretch/>
        </p:blipFill>
        <p:spPr>
          <a:xfrm>
            <a:off x="858419" y="5814527"/>
            <a:ext cx="3952648" cy="3029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36115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A99CC67-343B-44EC-A571-6B6B94039D05}"/>
              </a:ext>
            </a:extLst>
          </p:cNvPr>
          <p:cNvSpPr txBox="1"/>
          <p:nvPr/>
        </p:nvSpPr>
        <p:spPr>
          <a:xfrm>
            <a:off x="344129" y="27061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1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50E3F67F-E230-42F6-B670-519628A52F27}"/>
              </a:ext>
            </a:extLst>
          </p:cNvPr>
          <p:cNvSpPr txBox="1"/>
          <p:nvPr/>
        </p:nvSpPr>
        <p:spPr>
          <a:xfrm>
            <a:off x="317880" y="692475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xmlns="" id="{8B12EC8C-8D49-4618-9C16-3DE37BA6B37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778" t="7260" r="5889" b="60528"/>
          <a:stretch/>
        </p:blipFill>
        <p:spPr>
          <a:xfrm>
            <a:off x="222188" y="877141"/>
            <a:ext cx="6413624" cy="33455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82219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9488" y="763027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4129" y="27061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2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xmlns="" id="{C0705FE9-5604-464B-A7D8-78C5D6E8253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126" b="34810"/>
          <a:stretch/>
        </p:blipFill>
        <p:spPr>
          <a:xfrm>
            <a:off x="93945" y="1132359"/>
            <a:ext cx="6670110" cy="20813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39191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9488" y="763027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4129" y="27061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3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129" y="1132359"/>
            <a:ext cx="6200572" cy="33221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16700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569627" y="820177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50139" y="6145832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4129" y="27061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4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xmlns="" id="{2F4C7D05-F749-49F0-988D-C066436F5E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9834" y="820177"/>
            <a:ext cx="4878332" cy="5202572"/>
          </a:xfrm>
          <a:prstGeom prst="rect">
            <a:avLst/>
          </a:prstGeom>
        </p:spPr>
      </p:pic>
      <p:pic>
        <p:nvPicPr>
          <p:cNvPr id="9" name="내용 개체 틀 4">
            <a:extLst>
              <a:ext uri="{FF2B5EF4-FFF2-40B4-BE49-F238E27FC236}">
                <a16:creationId xmlns:a16="http://schemas.microsoft.com/office/drawing/2014/main" xmlns="" id="{7EECAB74-E81F-4825-A382-C8F90B2A0FD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392" b="21900"/>
          <a:stretch/>
        </p:blipFill>
        <p:spPr>
          <a:xfrm>
            <a:off x="989834" y="6145832"/>
            <a:ext cx="3317918" cy="3223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69341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9488" y="763027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4129" y="27061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4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xmlns="" id="{3A4CC98F-0409-4AB7-8755-673497352433}"/>
              </a:ext>
            </a:extLst>
          </p:cNvPr>
          <p:cNvGrpSpPr/>
          <p:nvPr/>
        </p:nvGrpSpPr>
        <p:grpSpPr>
          <a:xfrm>
            <a:off x="49783" y="882834"/>
            <a:ext cx="6758434" cy="3254194"/>
            <a:chOff x="49783" y="717734"/>
            <a:chExt cx="6758434" cy="3254194"/>
          </a:xfrm>
        </p:grpSpPr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xmlns="" id="{150DD694-CF95-486B-91BE-C0BE08871B2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783" y="834467"/>
              <a:ext cx="6758434" cy="3137461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xmlns="" id="{8A1FA379-4BAD-4AAA-ABCC-AEBBDF66D6D0}"/>
                </a:ext>
              </a:extLst>
            </p:cNvPr>
            <p:cNvSpPr txBox="1"/>
            <p:nvPr/>
          </p:nvSpPr>
          <p:spPr>
            <a:xfrm>
              <a:off x="472683" y="717734"/>
              <a:ext cx="2152649" cy="49244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300" dirty="0"/>
                <a:t>Gene ontology upregulated in the Group B</a:t>
              </a:r>
              <a:endParaRPr lang="ko-KR" altLang="en-US" sz="13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D2222FED-34FA-4014-AD19-9514112DFE14}"/>
                </a:ext>
              </a:extLst>
            </p:cNvPr>
            <p:cNvSpPr txBox="1"/>
            <p:nvPr/>
          </p:nvSpPr>
          <p:spPr>
            <a:xfrm>
              <a:off x="3596883" y="724083"/>
              <a:ext cx="2238767" cy="49244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300" dirty="0"/>
                <a:t>Gene ontology downregulated in the Group B</a:t>
              </a:r>
              <a:endParaRPr lang="ko-KR" altLang="en-US" sz="1300" dirty="0"/>
            </a:p>
          </p:txBody>
        </p:sp>
      </p:grpSp>
    </p:spTree>
    <p:extLst>
      <p:ext uri="{BB962C8B-B14F-4D97-AF65-F5344CB8AC3E}">
        <p14:creationId xmlns:p14="http://schemas.microsoft.com/office/powerpoint/2010/main" val="34569328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7137" y="875280"/>
            <a:ext cx="4446316" cy="20385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27351" y="35450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3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6903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24</TotalTime>
  <Words>93</Words>
  <Application>Microsoft Office PowerPoint</Application>
  <PresentationFormat>A4 Paper (210x297 mm)</PresentationFormat>
  <Paragraphs>1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 seon</dc:creator>
  <cp:lastModifiedBy>Jasmine H.</cp:lastModifiedBy>
  <cp:revision>106</cp:revision>
  <cp:lastPrinted>2020-07-02T02:21:16Z</cp:lastPrinted>
  <dcterms:created xsi:type="dcterms:W3CDTF">2019-04-09T02:08:37Z</dcterms:created>
  <dcterms:modified xsi:type="dcterms:W3CDTF">2020-11-07T12:52:36Z</dcterms:modified>
</cp:coreProperties>
</file>